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33A356-C402-4D04-AEFF-F5EC895D1A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486FA1-08CD-493D-9015-DB2BBF6EA5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2E5559-0A33-4D09-AAAB-FC02E6FEE22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B7B8E-3F97-4681-8F99-2C1A0F182F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7F1AC8-B41A-4992-98F4-F46C69B681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DBA5E6-A06B-43F3-8B40-FB26E9B44A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33902D-93AE-48FC-AE01-238427E916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9B5B70-DED6-49EB-A9BC-9D96285384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21C06C-64E7-40FB-A2B0-48F7C544A1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7CB79B-E819-482D-9887-A89CFB08CE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C62818-7051-4FDB-A1B2-C1167E6953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4573A8-FAB4-4A21-897E-DE40471440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F57B3F-1AF8-4607-BA23-C85CA0CB3FF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31560" y="191160"/>
            <a:ext cx="4006800" cy="6435720"/>
            <a:chOff x="331560" y="191160"/>
            <a:chExt cx="4006800" cy="6435720"/>
          </a:xfrm>
        </p:grpSpPr>
        <p:grpSp>
          <p:nvGrpSpPr>
            <p:cNvPr id="42" name=""/>
            <p:cNvGrpSpPr/>
            <p:nvPr/>
          </p:nvGrpSpPr>
          <p:grpSpPr>
            <a:xfrm>
              <a:off x="331560" y="191160"/>
              <a:ext cx="3682080" cy="6355440"/>
              <a:chOff x="331560" y="191160"/>
              <a:chExt cx="3682080" cy="6355440"/>
            </a:xfrm>
          </p:grpSpPr>
          <p:sp>
            <p:nvSpPr>
              <p:cNvPr id="43" name=""/>
              <p:cNvSpPr/>
              <p:nvPr/>
            </p:nvSpPr>
            <p:spPr>
              <a:xfrm>
                <a:off x="331560" y="685800"/>
                <a:ext cx="178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 flipV="1">
                <a:off x="510480" y="558720"/>
                <a:ext cx="0" cy="126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510480" y="559080"/>
                <a:ext cx="630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 flipV="1">
                <a:off x="573480" y="348840"/>
                <a:ext cx="0" cy="210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573480" y="348840"/>
                <a:ext cx="199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 flipV="1">
                <a:off x="773280" y="232920"/>
                <a:ext cx="0" cy="115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773280" y="233280"/>
                <a:ext cx="157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773280" y="34884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773280" y="422280"/>
                <a:ext cx="42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 flipV="1">
                <a:off x="815400" y="369720"/>
                <a:ext cx="0" cy="522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815400" y="370080"/>
                <a:ext cx="126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815400" y="422280"/>
                <a:ext cx="0" cy="943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815400" y="516960"/>
                <a:ext cx="3787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573480" y="559080"/>
                <a:ext cx="0" cy="178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573480" y="738360"/>
                <a:ext cx="146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 flipV="1">
                <a:off x="720720" y="653760"/>
                <a:ext cx="0" cy="84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440" bIns="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720720" y="653760"/>
                <a:ext cx="221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720720" y="738360"/>
                <a:ext cx="0" cy="522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720720" y="790560"/>
                <a:ext cx="115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510480" y="685800"/>
                <a:ext cx="0" cy="252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510480" y="938160"/>
                <a:ext cx="431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510480" y="685800"/>
                <a:ext cx="0" cy="3829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510480" y="4515480"/>
                <a:ext cx="18097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 flipV="1">
                <a:off x="2320200" y="3042360"/>
                <a:ext cx="0" cy="1472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2320200" y="3042720"/>
                <a:ext cx="31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 flipV="1">
                <a:off x="2351520" y="1327320"/>
                <a:ext cx="0" cy="1715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2351520" y="1327320"/>
                <a:ext cx="3891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 flipV="1">
                <a:off x="2741040" y="1180080"/>
                <a:ext cx="0" cy="146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2741040" y="1180080"/>
                <a:ext cx="42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 flipV="1">
                <a:off x="2783160" y="1074600"/>
                <a:ext cx="0" cy="105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2783160" y="1074600"/>
                <a:ext cx="94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2783160" y="1180080"/>
                <a:ext cx="0" cy="105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2783160" y="1285560"/>
                <a:ext cx="84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 flipV="1">
                <a:off x="2867400" y="1211040"/>
                <a:ext cx="0" cy="73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2867400" y="1211400"/>
                <a:ext cx="31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2867400" y="128556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2867400" y="1359000"/>
                <a:ext cx="41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2741040" y="1327320"/>
                <a:ext cx="0" cy="168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2741040" y="1495800"/>
                <a:ext cx="178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2351520" y="3042720"/>
                <a:ext cx="0" cy="1431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2351520" y="4473720"/>
                <a:ext cx="20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 flipV="1">
                <a:off x="2372760" y="2895480"/>
                <a:ext cx="0" cy="1578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2372760" y="2895480"/>
                <a:ext cx="84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 flipV="1">
                <a:off x="2457000" y="1706040"/>
                <a:ext cx="0" cy="11890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2457000" y="1706400"/>
                <a:ext cx="146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 flipV="1">
                <a:off x="2604240" y="163260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2604240" y="1632600"/>
                <a:ext cx="105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2604240" y="170640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2604240" y="1779840"/>
                <a:ext cx="199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2457000" y="2895480"/>
                <a:ext cx="0" cy="11469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2457000" y="4042440"/>
                <a:ext cx="83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 flipV="1">
                <a:off x="2540880" y="2474280"/>
                <a:ext cx="0" cy="15681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2540880" y="2474280"/>
                <a:ext cx="31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 flipV="1">
                <a:off x="2572560" y="1990080"/>
                <a:ext cx="0" cy="483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2572560" y="1990080"/>
                <a:ext cx="336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 flipV="1">
                <a:off x="2909160" y="191664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2909160" y="1916640"/>
                <a:ext cx="630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2909160" y="199008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2909160" y="2053440"/>
                <a:ext cx="105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2572560" y="2474280"/>
                <a:ext cx="0" cy="431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2572560" y="2905560"/>
                <a:ext cx="522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 flipV="1">
                <a:off x="2625120" y="2263320"/>
                <a:ext cx="0" cy="641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2625120" y="2263680"/>
                <a:ext cx="42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 flipV="1">
                <a:off x="2667240" y="2201040"/>
                <a:ext cx="0" cy="62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2667240" y="2201040"/>
                <a:ext cx="262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2667240" y="226368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2667240" y="2337480"/>
                <a:ext cx="367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2625120" y="2905560"/>
                <a:ext cx="0" cy="631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2625120" y="3537360"/>
                <a:ext cx="20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 flipV="1">
                <a:off x="2646360" y="2695320"/>
                <a:ext cx="0" cy="841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2646360" y="2695320"/>
                <a:ext cx="42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 flipV="1">
                <a:off x="2688480" y="2548080"/>
                <a:ext cx="0" cy="146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2688480" y="2548080"/>
                <a:ext cx="210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 flipV="1">
                <a:off x="2898720" y="2473920"/>
                <a:ext cx="0" cy="73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2898720" y="2474280"/>
                <a:ext cx="73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2898720" y="254808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2898720" y="2621880"/>
                <a:ext cx="84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2688480" y="2695320"/>
                <a:ext cx="0" cy="136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2688480" y="2832120"/>
                <a:ext cx="94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 flipV="1">
                <a:off x="2783160" y="275868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2783160" y="2758680"/>
                <a:ext cx="146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2783160" y="283212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2783160" y="2895480"/>
                <a:ext cx="168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2646360" y="3537360"/>
                <a:ext cx="0" cy="830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2646360" y="4368600"/>
                <a:ext cx="31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 flipV="1">
                <a:off x="2677680" y="3768480"/>
                <a:ext cx="0" cy="599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2677680" y="3768840"/>
                <a:ext cx="178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 flipV="1">
                <a:off x="2856600" y="3358440"/>
                <a:ext cx="0" cy="410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2856600" y="3358440"/>
                <a:ext cx="94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 flipV="1">
                <a:off x="2951280" y="3147840"/>
                <a:ext cx="0" cy="210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2951280" y="3147840"/>
                <a:ext cx="73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 flipV="1">
                <a:off x="3025080" y="3042720"/>
                <a:ext cx="0" cy="105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3025080" y="3042720"/>
                <a:ext cx="157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3025080" y="3147840"/>
                <a:ext cx="0" cy="104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3025080" y="3252960"/>
                <a:ext cx="10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 flipV="1">
                <a:off x="3035520" y="317952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3035520" y="3179520"/>
                <a:ext cx="73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3035520" y="325296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3035520" y="3316320"/>
                <a:ext cx="1260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2951280" y="3358440"/>
                <a:ext cx="0" cy="210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2951280" y="3568680"/>
                <a:ext cx="115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 flipV="1">
                <a:off x="3066840" y="3463200"/>
                <a:ext cx="0" cy="104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3066840" y="3463560"/>
                <a:ext cx="136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3066840" y="3568680"/>
                <a:ext cx="0" cy="105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3066840" y="3674160"/>
                <a:ext cx="147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 flipV="1">
                <a:off x="3214440" y="3599640"/>
                <a:ext cx="0" cy="73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3214440" y="3600000"/>
                <a:ext cx="146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3214440" y="3674160"/>
                <a:ext cx="0" cy="62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3214440" y="3736800"/>
                <a:ext cx="1260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2856600" y="3768840"/>
                <a:ext cx="0" cy="410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2856600" y="4179240"/>
                <a:ext cx="84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 flipV="1">
                <a:off x="2940840" y="4052520"/>
                <a:ext cx="0" cy="126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2940840" y="4052880"/>
                <a:ext cx="42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 flipV="1">
                <a:off x="2982960" y="3947400"/>
                <a:ext cx="0" cy="104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2982960" y="3947760"/>
                <a:ext cx="20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 flipV="1">
                <a:off x="3004200" y="388404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3004200" y="3884400"/>
                <a:ext cx="31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3004200" y="394776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3004200" y="4021200"/>
                <a:ext cx="522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2982960" y="4052880"/>
                <a:ext cx="0" cy="105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2982960" y="4158000"/>
                <a:ext cx="42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2940840" y="4179240"/>
                <a:ext cx="0" cy="126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2940840" y="4305240"/>
                <a:ext cx="146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2677680" y="4368600"/>
                <a:ext cx="0" cy="5680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2677680" y="4936680"/>
                <a:ext cx="42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 flipV="1">
                <a:off x="2719800" y="4673160"/>
                <a:ext cx="0" cy="2631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2719800" y="4673520"/>
                <a:ext cx="20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 flipV="1">
                <a:off x="2741040" y="4442040"/>
                <a:ext cx="0" cy="231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2741040" y="4442040"/>
                <a:ext cx="452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2741040" y="4673520"/>
                <a:ext cx="0" cy="210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2741040" y="4883760"/>
                <a:ext cx="630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 flipV="1">
                <a:off x="2804040" y="4757760"/>
                <a:ext cx="0" cy="126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2804040" y="4757760"/>
                <a:ext cx="3996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 flipV="1">
                <a:off x="3203640" y="4652640"/>
                <a:ext cx="0" cy="105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3203640" y="4652640"/>
                <a:ext cx="115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 flipV="1">
                <a:off x="3319560" y="457884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3319560" y="4578840"/>
                <a:ext cx="105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3319560" y="4652640"/>
                <a:ext cx="0" cy="73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3319560" y="4726440"/>
                <a:ext cx="52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3203640" y="4757760"/>
                <a:ext cx="0" cy="104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3203640" y="4862880"/>
                <a:ext cx="347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2804040" y="4883760"/>
                <a:ext cx="0" cy="115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2804040" y="4999680"/>
                <a:ext cx="410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2719800" y="4936680"/>
                <a:ext cx="0" cy="273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2719800" y="5210280"/>
                <a:ext cx="168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 flipV="1">
                <a:off x="2888280" y="514692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2888280" y="5147280"/>
                <a:ext cx="304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2888280" y="521028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2888280" y="5284080"/>
                <a:ext cx="946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2540880" y="4042440"/>
                <a:ext cx="0" cy="1599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2540880" y="5641560"/>
                <a:ext cx="52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 flipV="1">
                <a:off x="2593800" y="5494320"/>
                <a:ext cx="0" cy="146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2593800" y="5494320"/>
                <a:ext cx="1890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 flipV="1">
                <a:off x="2783160" y="542088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2783160" y="5420880"/>
                <a:ext cx="157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2783160" y="549432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2783160" y="5568120"/>
                <a:ext cx="84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2593800" y="5641560"/>
                <a:ext cx="0" cy="136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2593800" y="5778360"/>
                <a:ext cx="94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 flipV="1">
                <a:off x="2688480" y="570492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2688480" y="5704920"/>
                <a:ext cx="73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2688480" y="577836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2688480" y="5841720"/>
                <a:ext cx="136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2372760" y="4473720"/>
                <a:ext cx="0" cy="1588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2372760" y="6062760"/>
                <a:ext cx="94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 flipV="1">
                <a:off x="2467440" y="598932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2467440" y="5989320"/>
                <a:ext cx="3787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2467440" y="6062760"/>
                <a:ext cx="0" cy="62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2467440" y="6125400"/>
                <a:ext cx="2736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2320200" y="4515480"/>
                <a:ext cx="0" cy="1851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2320200" y="6367680"/>
                <a:ext cx="5151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 flipV="1">
                <a:off x="2835720" y="6262560"/>
                <a:ext cx="0" cy="105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2835720" y="6262560"/>
                <a:ext cx="136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2835720" y="6367680"/>
                <a:ext cx="0" cy="105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2835720" y="6473160"/>
                <a:ext cx="105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 flipV="1">
                <a:off x="2940840" y="640944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2940840" y="6409800"/>
                <a:ext cx="31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2940840" y="647316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2940840" y="6546600"/>
                <a:ext cx="294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967320" y="19116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At2g0194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979200" y="32796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At1g6813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1231560" y="47484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At1g2525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983880" y="611640"/>
                <a:ext cx="483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Bd3g3789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877680" y="748440"/>
                <a:ext cx="483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Bd4g3177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983880" y="896040"/>
                <a:ext cx="483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Bd1g6873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2935800" y="1032840"/>
                <a:ext cx="941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BdID1_Bd3g26910 ▼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2941920" y="1169640"/>
                <a:ext cx="811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ZmID1_O65215 ▼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2985480" y="1316880"/>
                <a:ext cx="1020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SbID1_Sb01g021480 ▼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2992320" y="1453680"/>
                <a:ext cx="995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OsID1_Os10g28330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Times New Roman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▼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2733480" y="1590480"/>
                <a:ext cx="1131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OsIDD2_Os01g09850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▼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2837880" y="1737720"/>
                <a:ext cx="1175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BdIDD2_Bradi2g05900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▼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>
                <a:off x="3022920" y="1874520"/>
                <a:ext cx="528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Os01g391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3054960" y="2011320"/>
                <a:ext cx="483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Bd2g4155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2966040" y="215892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At3g138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3071880" y="229572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At1g551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>
                <a:off x="3022920" y="2442960"/>
                <a:ext cx="528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Os03g1014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3022920" y="2579760"/>
                <a:ext cx="483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Bd1g7133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>
                <a:off x="2966040" y="271656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At5g6673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2985840" y="286344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At3g507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3231720" y="3000240"/>
                <a:ext cx="528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Os08g4405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43" name=""/>
            <p:cNvSpPr/>
            <p:nvPr/>
          </p:nvSpPr>
          <p:spPr>
            <a:xfrm>
              <a:off x="3160080" y="313740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9g383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3203280" y="328500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4g375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3240360" y="342180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2g020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3398400" y="355860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2g020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3377160" y="370584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1g145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3086640" y="384264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2g4505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3109320" y="397944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5g185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3090600" y="4126680"/>
              <a:ext cx="605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4g4786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3130560" y="426348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3g510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3229920" y="440028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5g031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3475800" y="454752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2g318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3414600" y="468468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3g445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3602880" y="482148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5g085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3252240" y="496836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4g026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3229920" y="510516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3g452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3872880" y="524196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5g604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2977560" y="538920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5g441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2903760" y="552600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1g038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2813040" y="566280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1g140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2866320" y="581040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2g084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2895480" y="5947200"/>
              <a:ext cx="1014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IDD9_Bd2g60020 ▼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2804040" y="6084000"/>
              <a:ext cx="1050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IDD9_Os01g70870 ▼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3023280" y="623124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7g393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3014640" y="636804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1g234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3287520" y="650484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1g183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8" name=""/>
          <p:cNvSpPr/>
          <p:nvPr/>
        </p:nvSpPr>
        <p:spPr>
          <a:xfrm>
            <a:off x="2052000" y="4351320"/>
            <a:ext cx="326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2520000" y="117324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2440440" y="134928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2575800" y="6208560"/>
            <a:ext cx="326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3063240" y="4495680"/>
            <a:ext cx="326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2850120" y="353052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1918080" y="333684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2686680" y="238608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2574000" y="534024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564120" y="18900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 flipV="1">
            <a:off x="2655720" y="1312560"/>
            <a:ext cx="184320" cy="106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2133720" y="3433680"/>
            <a:ext cx="853920" cy="4906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2689920" y="182736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5292720" y="836640"/>
            <a:ext cx="2665440" cy="170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At = Arabidopsi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Os = Ric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Bd = Brachypodium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Bootstrap support of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≥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90% show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1000 dataset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▼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  <a:ea typeface="Arial"/>
              </a:rPr>
              <a:t>proteins selected for Figure 7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2T10:53:22Z</dcterms:created>
  <dc:creator>Janet Higgins</dc:creator>
  <dc:description/>
  <dc:language>en-US</dc:language>
  <cp:lastModifiedBy>Janet Higgins</cp:lastModifiedBy>
  <dcterms:modified xsi:type="dcterms:W3CDTF">2010-01-06T11:57:04Z</dcterms:modified>
  <cp:revision>8</cp:revision>
  <dc:subject/>
  <dc:title>Slide 1</dc:title>
</cp:coreProperties>
</file>